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2CCCDA-2735-4CD6-B96E-539F11575C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754FC7-734D-439F-9974-37C3A6023C7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98A00-AE20-4B42-B815-54BB6C5F49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E9568E-94AD-4C1E-8761-B881763EBA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AA002-03B8-4D99-BE96-7447A82D3D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2BA57-E580-44B7-BF81-ABD703F51C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E1BC9-52EF-4B98-B387-A12469C43EF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3322CD-3B45-4B34-BE34-A3065D60F3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23AA5C-EBA8-4DB7-B2FE-CA4399FCF3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78903-45B0-499D-88A9-074017A90B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CACC8-EC8E-48E4-B1BD-CA44DCA19F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7F7F20-7749-4DB8-9845-0A80DD10C0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1A3F03-BE36-4235-845A-5672449AD2B6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3" descr=""/>
          <p:cNvPicPr/>
          <p:nvPr/>
        </p:nvPicPr>
        <p:blipFill>
          <a:blip r:embed="rId1"/>
          <a:stretch/>
        </p:blipFill>
        <p:spPr>
          <a:xfrm>
            <a:off x="3193920" y="993600"/>
            <a:ext cx="5346720" cy="315756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4"/>
          <p:cNvSpPr/>
          <p:nvPr/>
        </p:nvSpPr>
        <p:spPr>
          <a:xfrm>
            <a:off x="3821040" y="4146480"/>
            <a:ext cx="215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Nase(+)/DNase(-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5"/>
          <p:cNvSpPr/>
          <p:nvPr/>
        </p:nvSpPr>
        <p:spPr>
          <a:xfrm>
            <a:off x="6186240" y="4146480"/>
            <a:ext cx="2152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Nase(+)/DNase(-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6"/>
          <p:cNvSpPr/>
          <p:nvPr/>
        </p:nvSpPr>
        <p:spPr>
          <a:xfrm>
            <a:off x="4477680" y="601560"/>
            <a:ext cx="817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TF3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7"/>
          <p:cNvSpPr/>
          <p:nvPr/>
        </p:nvSpPr>
        <p:spPr>
          <a:xfrm>
            <a:off x="6789600" y="601560"/>
            <a:ext cx="817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ATF4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テキスト ボックス 8"/>
          <p:cNvSpPr/>
          <p:nvPr/>
        </p:nvSpPr>
        <p:spPr>
          <a:xfrm>
            <a:off x="3210480" y="4624560"/>
            <a:ext cx="7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ea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テキスト ボックス 9"/>
          <p:cNvSpPr/>
          <p:nvPr/>
        </p:nvSpPr>
        <p:spPr>
          <a:xfrm>
            <a:off x="4288320" y="4640400"/>
            <a:ext cx="119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.03±0.2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11"/>
          <p:cNvSpPr/>
          <p:nvPr/>
        </p:nvSpPr>
        <p:spPr>
          <a:xfrm>
            <a:off x="6590160" y="4640400"/>
            <a:ext cx="1192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.11±0.25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13"/>
          <p:cNvSpPr/>
          <p:nvPr/>
        </p:nvSpPr>
        <p:spPr>
          <a:xfrm rot="16200000">
            <a:off x="1700640" y="2174760"/>
            <a:ext cx="2644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Ratio of gene expression 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14"/>
          <p:cNvSpPr/>
          <p:nvPr/>
        </p:nvSpPr>
        <p:spPr>
          <a:xfrm>
            <a:off x="233280" y="233280"/>
            <a:ext cx="253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</a:t>
            </a:r>
            <a:r>
              <a:rPr b="1" lang="ja-JP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ur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テキスト ボックス 2"/>
          <p:cNvSpPr/>
          <p:nvPr/>
        </p:nvSpPr>
        <p:spPr>
          <a:xfrm>
            <a:off x="2774520" y="5135400"/>
            <a:ext cx="108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PMI-822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直線コネクタ 12"/>
          <p:cNvSpPr/>
          <p:nvPr/>
        </p:nvSpPr>
        <p:spPr>
          <a:xfrm>
            <a:off x="2916360" y="5081760"/>
            <a:ext cx="5619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15"/>
          <p:cNvSpPr/>
          <p:nvPr/>
        </p:nvSpPr>
        <p:spPr>
          <a:xfrm>
            <a:off x="3243240" y="5575320"/>
            <a:ext cx="605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U22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16"/>
          <p:cNvSpPr/>
          <p:nvPr/>
        </p:nvSpPr>
        <p:spPr>
          <a:xfrm>
            <a:off x="3065040" y="6016680"/>
            <a:ext cx="823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KMS-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10"/>
          <p:cNvSpPr/>
          <p:nvPr/>
        </p:nvSpPr>
        <p:spPr>
          <a:xfrm>
            <a:off x="4596120" y="514512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.9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テキスト ボックス 17"/>
          <p:cNvSpPr/>
          <p:nvPr/>
        </p:nvSpPr>
        <p:spPr>
          <a:xfrm>
            <a:off x="4596120" y="556416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.8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テキスト ボックス 18"/>
          <p:cNvSpPr/>
          <p:nvPr/>
        </p:nvSpPr>
        <p:spPr>
          <a:xfrm>
            <a:off x="4596120" y="597708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.3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19"/>
          <p:cNvSpPr/>
          <p:nvPr/>
        </p:nvSpPr>
        <p:spPr>
          <a:xfrm>
            <a:off x="6867000" y="514836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.3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20"/>
          <p:cNvSpPr/>
          <p:nvPr/>
        </p:nvSpPr>
        <p:spPr>
          <a:xfrm>
            <a:off x="6867000" y="556740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.0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21"/>
          <p:cNvSpPr/>
          <p:nvPr/>
        </p:nvSpPr>
        <p:spPr>
          <a:xfrm>
            <a:off x="6867000" y="5979960"/>
            <a:ext cx="52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0.89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9-09T10:06:26Z</dcterms:created>
  <dc:creator>李政樹</dc:creator>
  <dc:description/>
  <dc:language>en-US</dc:language>
  <cp:lastModifiedBy>ravikumar.n</cp:lastModifiedBy>
  <dcterms:modified xsi:type="dcterms:W3CDTF">2015-11-26T10:55:03Z</dcterms:modified>
  <cp:revision>12</cp:revision>
  <dc:subject/>
  <dc:title>PowerPoint プレゼンテーション</dc:title>
</cp:coreProperties>
</file>